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776CC-245C-481C-A68F-46210D15A0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FF937-8DF0-4753-9E67-9A7D589B82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E8248-D8E5-4D0F-88D6-AA591656A3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2DFBC-25F3-46B1-9EF7-D9F6D6838B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DF870-2816-4CF2-B99C-AC0B4176C5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61778-7AA5-4005-878D-52057EAFBB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A61BC-68D9-46A9-8C00-C6BA67A8B5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02BB0-11C6-4599-BBB9-099901FB7D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D2AF7-6DCE-4ECD-9848-BA0F99958D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34755-8F96-4D5A-9EE5-CE412E8918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00DE0-9313-4040-9774-AF94E31C15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D967B-FC94-4D77-897C-2DB331355E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800BDE9-F259-4EBC-BA24-29099E50AB09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BF746C-8116-4619-BEE6-700C076D71C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930240" y="976320"/>
            <a:ext cx="3414600" cy="3182760"/>
            <a:chOff x="930240" y="976320"/>
            <a:chExt cx="3414600" cy="3182760"/>
          </a:xfrm>
        </p:grpSpPr>
        <p:pic>
          <p:nvPicPr>
            <p:cNvPr id="42" name="Picture 8" descr=""/>
            <p:cNvPicPr/>
            <p:nvPr/>
          </p:nvPicPr>
          <p:blipFill>
            <a:blip r:embed="rId1"/>
            <a:stretch/>
          </p:blipFill>
          <p:spPr>
            <a:xfrm>
              <a:off x="930240" y="976320"/>
              <a:ext cx="3414600" cy="306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9"/>
            <p:cNvSpPr/>
            <p:nvPr/>
          </p:nvSpPr>
          <p:spPr>
            <a:xfrm rot="16200000">
              <a:off x="608040" y="2291760"/>
              <a:ext cx="93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Cell numbe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ZoneTexte 79"/>
            <p:cNvSpPr/>
            <p:nvPr/>
          </p:nvSpPr>
          <p:spPr>
            <a:xfrm>
              <a:off x="1518480" y="3882600"/>
              <a:ext cx="222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CD39 MFI on </a:t>
              </a:r>
              <a:r>
                <a:rPr b="1" lang="en-GB" sz="12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YT2C2 NK line cel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5" name="Grouper 58"/>
          <p:cNvGrpSpPr/>
          <p:nvPr/>
        </p:nvGrpSpPr>
        <p:grpSpPr>
          <a:xfrm>
            <a:off x="4743360" y="-1674720"/>
            <a:ext cx="3084480" cy="5699520"/>
            <a:chOff x="4743360" y="-1674720"/>
            <a:chExt cx="3084480" cy="5699520"/>
          </a:xfrm>
        </p:grpSpPr>
        <p:grpSp>
          <p:nvGrpSpPr>
            <p:cNvPr id="46" name="Grouper 6"/>
            <p:cNvGrpSpPr/>
            <p:nvPr/>
          </p:nvGrpSpPr>
          <p:grpSpPr>
            <a:xfrm>
              <a:off x="4743360" y="-1674720"/>
              <a:ext cx="3084480" cy="5699520"/>
              <a:chOff x="4743360" y="-1674720"/>
              <a:chExt cx="3084480" cy="5699520"/>
            </a:xfrm>
          </p:grpSpPr>
          <p:sp>
            <p:nvSpPr>
              <p:cNvPr id="47" name="Text Box 31"/>
              <p:cNvSpPr/>
              <p:nvPr/>
            </p:nvSpPr>
            <p:spPr>
              <a:xfrm rot="16200000">
                <a:off x="3719160" y="2182320"/>
                <a:ext cx="2768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ATPase activity (%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Text Box 44"/>
              <p:cNvSpPr/>
              <p:nvPr/>
            </p:nvSpPr>
            <p:spPr>
              <a:xfrm>
                <a:off x="6159240" y="603360"/>
                <a:ext cx="320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ns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49" name="Picture 13" descr=""/>
              <p:cNvPicPr/>
              <p:nvPr/>
            </p:nvPicPr>
            <p:blipFill>
              <a:blip r:embed="rId2"/>
              <a:stretch/>
            </p:blipFill>
            <p:spPr>
              <a:xfrm>
                <a:off x="5224680" y="990000"/>
                <a:ext cx="2379240" cy="2797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Rectangle 10"/>
              <p:cNvSpPr/>
              <p:nvPr/>
            </p:nvSpPr>
            <p:spPr>
              <a:xfrm>
                <a:off x="4743360" y="3689640"/>
                <a:ext cx="3041640" cy="24912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ZoneTexte 12"/>
              <p:cNvSpPr/>
              <p:nvPr/>
            </p:nvSpPr>
            <p:spPr>
              <a:xfrm>
                <a:off x="5391000" y="3738960"/>
                <a:ext cx="1117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Mediu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ZoneTexte 13"/>
              <p:cNvSpPr/>
              <p:nvPr/>
            </p:nvSpPr>
            <p:spPr>
              <a:xfrm>
                <a:off x="6062400" y="3738960"/>
                <a:ext cx="111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IgG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ZoneTexte 14"/>
              <p:cNvSpPr/>
              <p:nvPr/>
            </p:nvSpPr>
            <p:spPr>
              <a:xfrm>
                <a:off x="6602400" y="3748320"/>
                <a:ext cx="1225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BY4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4" name="Group 39"/>
              <p:cNvGrpSpPr/>
              <p:nvPr/>
            </p:nvGrpSpPr>
            <p:grpSpPr>
              <a:xfrm>
                <a:off x="5977440" y="-1674720"/>
                <a:ext cx="702000" cy="0"/>
                <a:chOff x="5977440" y="-1674720"/>
                <a:chExt cx="702000" cy="0"/>
              </a:xfrm>
            </p:grpSpPr>
            <p:sp>
              <p:nvSpPr>
                <p:cNvPr id="55" name="Line 41"/>
                <p:cNvSpPr/>
                <p:nvPr/>
              </p:nvSpPr>
              <p:spPr>
                <a:xfrm>
                  <a:off x="5977440" y="-1674720"/>
                  <a:ext cx="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Line 42"/>
                <p:cNvSpPr/>
                <p:nvPr/>
              </p:nvSpPr>
              <p:spPr>
                <a:xfrm>
                  <a:off x="6679440" y="-1674720"/>
                  <a:ext cx="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7" name="Text Box 43"/>
              <p:cNvSpPr/>
              <p:nvPr/>
            </p:nvSpPr>
            <p:spPr>
              <a:xfrm>
                <a:off x="6516720" y="1068480"/>
                <a:ext cx="3124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Calibri"/>
                  </a:rPr>
                  <a:t>*</a:t>
                </a:r>
                <a:endParaRPr b="0" lang="en-US" sz="2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8" name="Group 39"/>
              <p:cNvGrpSpPr/>
              <p:nvPr/>
            </p:nvGrpSpPr>
            <p:grpSpPr>
              <a:xfrm>
                <a:off x="5974560" y="-1241280"/>
                <a:ext cx="1300320" cy="36360"/>
                <a:chOff x="5974560" y="-1241280"/>
                <a:chExt cx="1300320" cy="36360"/>
              </a:xfrm>
            </p:grpSpPr>
            <p:sp>
              <p:nvSpPr>
                <p:cNvPr id="59" name="Line 41"/>
                <p:cNvSpPr/>
                <p:nvPr/>
              </p:nvSpPr>
              <p:spPr>
                <a:xfrm>
                  <a:off x="5974560" y="-1241280"/>
                  <a:ext cx="0" cy="36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Line 42"/>
                <p:cNvSpPr/>
                <p:nvPr/>
              </p:nvSpPr>
              <p:spPr>
                <a:xfrm>
                  <a:off x="7274880" y="-1241280"/>
                  <a:ext cx="0" cy="36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61" name="Line 40"/>
            <p:cNvSpPr/>
            <p:nvPr/>
          </p:nvSpPr>
          <p:spPr>
            <a:xfrm>
              <a:off x="5978520" y="922320"/>
              <a:ext cx="70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41"/>
            <p:cNvSpPr/>
            <p:nvPr/>
          </p:nvSpPr>
          <p:spPr>
            <a:xfrm>
              <a:off x="5978520" y="922320"/>
              <a:ext cx="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42"/>
            <p:cNvSpPr/>
            <p:nvPr/>
          </p:nvSpPr>
          <p:spPr>
            <a:xfrm>
              <a:off x="6680160" y="922320"/>
              <a:ext cx="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40"/>
            <p:cNvSpPr/>
            <p:nvPr/>
          </p:nvSpPr>
          <p:spPr>
            <a:xfrm>
              <a:off x="5975280" y="1330560"/>
              <a:ext cx="12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41"/>
            <p:cNvSpPr/>
            <p:nvPr/>
          </p:nvSpPr>
          <p:spPr>
            <a:xfrm>
              <a:off x="5975280" y="1330560"/>
              <a:ext cx="0" cy="18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42"/>
            <p:cNvSpPr/>
            <p:nvPr/>
          </p:nvSpPr>
          <p:spPr>
            <a:xfrm>
              <a:off x="7275600" y="1330560"/>
              <a:ext cx="0" cy="18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Text Box 96"/>
          <p:cNvSpPr/>
          <p:nvPr/>
        </p:nvSpPr>
        <p:spPr>
          <a:xfrm>
            <a:off x="508680" y="45252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96"/>
          <p:cNvSpPr/>
          <p:nvPr/>
        </p:nvSpPr>
        <p:spPr>
          <a:xfrm>
            <a:off x="4565880" y="39204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74"/>
          <p:cNvSpPr/>
          <p:nvPr/>
        </p:nvSpPr>
        <p:spPr>
          <a:xfrm>
            <a:off x="5578920" y="6419880"/>
            <a:ext cx="336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upplementary Figure 3. 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Nikolova et a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2T09:19:21Z</dcterms:created>
  <dc:creator>Lelièvre Jean-Daniel</dc:creator>
  <dc:description/>
  <dc:language>en-US</dc:language>
  <cp:lastModifiedBy>Lelièvre Jean-Daniel</cp:lastModifiedBy>
  <dcterms:modified xsi:type="dcterms:W3CDTF">2010-11-22T11:04:37Z</dcterms:modified>
  <cp:revision>4</cp:revision>
  <dc:subject/>
  <dc:title>Diapositive 1</dc:title>
</cp:coreProperties>
</file>